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5AA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4" d="100"/>
          <a:sy n="74" d="100"/>
        </p:scale>
        <p:origin x="91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seph Laycock" userId="c4bfcbf4-3ccc-440e-b317-559baf184f0d" providerId="ADAL" clId="{6FFBB5CD-8E75-492C-A452-133F2C97F06E}"/>
    <pc:docChg chg="undo custSel modSld">
      <pc:chgData name="Joseph Laycock" userId="c4bfcbf4-3ccc-440e-b317-559baf184f0d" providerId="ADAL" clId="{6FFBB5CD-8E75-492C-A452-133F2C97F06E}" dt="2026-02-23T16:50:10.986" v="6" actId="113"/>
      <pc:docMkLst>
        <pc:docMk/>
      </pc:docMkLst>
      <pc:sldChg chg="addSp delSp modSp mod">
        <pc:chgData name="Joseph Laycock" userId="c4bfcbf4-3ccc-440e-b317-559baf184f0d" providerId="ADAL" clId="{6FFBB5CD-8E75-492C-A452-133F2C97F06E}" dt="2026-02-23T16:50:10.986" v="6" actId="113"/>
        <pc:sldMkLst>
          <pc:docMk/>
          <pc:sldMk cId="2867428870" sldId="268"/>
        </pc:sldMkLst>
        <pc:spChg chg="mod">
          <ac:chgData name="Joseph Laycock" userId="c4bfcbf4-3ccc-440e-b317-559baf184f0d" providerId="ADAL" clId="{6FFBB5CD-8E75-492C-A452-133F2C97F06E}" dt="2026-02-23T16:49:58.956" v="1" actId="113"/>
          <ac:spMkLst>
            <pc:docMk/>
            <pc:sldMk cId="2867428870" sldId="268"/>
            <ac:spMk id="24" creationId="{00000000-0000-0000-0000-000000000000}"/>
          </ac:spMkLst>
        </pc:spChg>
        <pc:spChg chg="add del mod">
          <ac:chgData name="Joseph Laycock" userId="c4bfcbf4-3ccc-440e-b317-559baf184f0d" providerId="ADAL" clId="{6FFBB5CD-8E75-492C-A452-133F2C97F06E}" dt="2026-02-23T16:50:10.986" v="6" actId="113"/>
          <ac:spMkLst>
            <pc:docMk/>
            <pc:sldMk cId="2867428870" sldId="268"/>
            <ac:spMk id="25" creationId="{00000000-0000-0000-0000-000000000000}"/>
          </ac:spMkLst>
        </pc:spChg>
        <pc:spChg chg="mod">
          <ac:chgData name="Joseph Laycock" userId="c4bfcbf4-3ccc-440e-b317-559baf184f0d" providerId="ADAL" clId="{6FFBB5CD-8E75-492C-A452-133F2C97F06E}" dt="2026-02-23T16:49:52.111" v="0" actId="113"/>
          <ac:spMkLst>
            <pc:docMk/>
            <pc:sldMk cId="2867428870" sldId="268"/>
            <ac:spMk id="28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BEFA9C-7D32-0D27-AC18-B2310E59C8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7DA48DA-3906-1DBA-D855-E34A1133F5D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2041DE-2A76-78C7-EB16-FF0DD0BC5C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20B77-37C6-4258-870F-4D3477348FFE}" type="datetimeFigureOut">
              <a:rPr lang="en-US" smtClean="0"/>
              <a:t>2/23/2026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F8569E-6F78-028C-669C-0006AC1AB3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EE28E5-BA9B-76CD-A88C-E1F2978A7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CBAF7-B4A8-4F84-8191-778DF9CF88A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67830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3D07BE-4CB0-BBE4-FBC3-51D95E8FFC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21E06F0-D37D-2D62-D0AE-2D9042325F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E30BB6-C87F-D139-D7FF-DC3BB0EA6A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20B77-37C6-4258-870F-4D3477348FFE}" type="datetimeFigureOut">
              <a:rPr lang="en-US" smtClean="0"/>
              <a:t>2/23/2026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109DD4-E285-881E-F954-6E69BB3AC0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6858C8-622F-92C9-79D3-8EAD138D09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CBAF7-B4A8-4F84-8191-778DF9CF88A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6572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9CCA25D-BEBA-752E-F192-2236DC28732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3434F5-EB25-5E44-D0E9-9D5C6ABE42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7D91C0-C476-9829-198F-A0CF51339D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20B77-37C6-4258-870F-4D3477348FFE}" type="datetimeFigureOut">
              <a:rPr lang="en-US" smtClean="0"/>
              <a:t>2/23/2026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CD4C06-A2D0-1344-5725-11C2480EAD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E7A43C-B076-F38A-1C29-F543DCB0DE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CBAF7-B4A8-4F84-8191-778DF9CF88A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6874975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29181012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25CF53-6E44-A869-1F14-2F46011355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5F81B2-4478-A451-D171-7D2C00E2F8C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6E0CC7-13AC-D2D3-A87F-F0E514C765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20B77-37C6-4258-870F-4D3477348FFE}" type="datetimeFigureOut">
              <a:rPr lang="en-US" smtClean="0"/>
              <a:t>2/23/2026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A43892-6114-516F-5E0D-1168140E63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504A90-90A3-AC17-05FA-E9D981708E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CBAF7-B4A8-4F84-8191-778DF9CF88A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682465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EA2E16-70E0-95A3-E197-A7C03BF3AD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D91035-0E0E-F5A0-177F-58844B1DDB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2BDDD9-362C-E45D-EFF3-A5A32E695B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20B77-37C6-4258-870F-4D3477348FFE}" type="datetimeFigureOut">
              <a:rPr lang="en-US" smtClean="0"/>
              <a:t>2/23/2026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A37203-5617-95C7-5CE9-D6AC2A180D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A9771B-89CF-EA88-55F8-25A23E725D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CBAF7-B4A8-4F84-8191-778DF9CF88A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007510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077579-5A2F-A59E-EB04-D068E34B25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3F75C4B-9731-35D2-AD1A-0D2DEAC7257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4049DE7-821E-1A4E-A8BA-CC0921E9CA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C0E2A2-57FC-F36A-C062-870FE06C8B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20B77-37C6-4258-870F-4D3477348FFE}" type="datetimeFigureOut">
              <a:rPr lang="en-US" smtClean="0"/>
              <a:t>2/23/2026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71A416-111F-B1D2-2E8C-D923EEE065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5E6471-BDD0-8D40-533D-ED51CE415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CBAF7-B4A8-4F84-8191-778DF9CF88A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98394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F56F9B-42B0-4C31-6180-03E32C98C8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1EC208-8A2E-2BFE-EB97-A6679B8299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480918F-FD68-085F-CC3B-767F4E990C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B1E0F60-E618-C371-AD62-A934E0CB5A5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7A70498-517F-ACFC-0BA3-2AFC306EAFE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6069580-1BA0-9B18-A0B4-7094C4300D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20B77-37C6-4258-870F-4D3477348FFE}" type="datetimeFigureOut">
              <a:rPr lang="en-US" smtClean="0"/>
              <a:t>2/23/2026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D20A114-5D58-F4C3-B95A-05BCD06870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947C8EF-286A-7C2A-A980-190F596A47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CBAF7-B4A8-4F84-8191-778DF9CF88A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02756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16DFC0-B53F-11D8-9532-3C94709313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71E8335-C65C-2D50-8BC3-9B917B397A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20B77-37C6-4258-870F-4D3477348FFE}" type="datetimeFigureOut">
              <a:rPr lang="en-US" smtClean="0"/>
              <a:t>2/23/2026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3D1218B-5284-E358-CA2D-4CB069C2A5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5B24E06-27CA-94C8-2934-DA8280CA8E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CBAF7-B4A8-4F84-8191-778DF9CF88A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400126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9782F33-3CF5-9C7D-7153-D104C72856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20B77-37C6-4258-870F-4D3477348FFE}" type="datetimeFigureOut">
              <a:rPr lang="en-US" smtClean="0"/>
              <a:t>2/23/2026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1D586C1-02F8-7BE2-FB87-F06201C245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7652CD1-C168-5CB5-7D37-B34A103FA1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CBAF7-B4A8-4F84-8191-778DF9CF88A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290061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F87A6A-30B5-D6E7-B067-E21A96EF58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EEE5B2-E993-FB4E-1227-67325EFB614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550E16A-1866-A8A7-87FB-BCD7696023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4EC81AE-C5C8-BC58-CDD6-F99085AAD9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20B77-37C6-4258-870F-4D3477348FFE}" type="datetimeFigureOut">
              <a:rPr lang="en-US" smtClean="0"/>
              <a:t>2/23/2026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2E8CB4-3436-C073-B5C3-AFA8EFC20A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BB5A5C-8617-6160-D3CF-6FC580C47D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CBAF7-B4A8-4F84-8191-778DF9CF88A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71836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ABDB04-99C6-464A-54A6-DA770366CB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A3D7022-E40A-EE1F-EB61-812BDBBFA4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ED9B27-AD3B-45C2-1F23-8DF3DB2220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40C8AE-3C03-3E2A-F1AD-AC82ABF430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20B77-37C6-4258-870F-4D3477348FFE}" type="datetimeFigureOut">
              <a:rPr lang="en-US" smtClean="0"/>
              <a:t>2/23/2026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B58CE0-55D4-AD65-93DC-F09D3D9786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86BE63-F472-5E5D-D5F3-F4F0DB0B7F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CBAF7-B4A8-4F84-8191-778DF9CF88A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99822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803D7E6-114B-9CE8-10B4-59E52C4C26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80B8C6-6DF3-C817-9F40-56F300901B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425676-3A71-2EF0-02E9-5435FB5D21C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6420B77-37C6-4258-870F-4D3477348FFE}" type="datetimeFigureOut">
              <a:rPr lang="en-US" smtClean="0"/>
              <a:t>2/23/2026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2ECE68-DCA8-9361-A87B-A8F49C50FC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F5934F-D87C-F3B1-EC94-B37F106C8FF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BDCBAF7-B4A8-4F84-8191-778DF9CF88A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750566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Picture 28" descr="A graph with a arrow pointing up&#10;&#10;AI-generated content may be incorrect.">
            <a:extLst>
              <a:ext uri="{FF2B5EF4-FFF2-40B4-BE49-F238E27FC236}">
                <a16:creationId xmlns:a16="http://schemas.microsoft.com/office/drawing/2014/main" id="{5B43B009-D282-1DBA-8086-7B93814391A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43209" y="3828421"/>
            <a:ext cx="2121742" cy="1711611"/>
          </a:xfrm>
          <a:prstGeom prst="rect">
            <a:avLst/>
          </a:prstGeom>
        </p:spPr>
      </p:pic>
      <p:pic>
        <p:nvPicPr>
          <p:cNvPr id="35" name="Picture 34" descr="A green triangle with a skull and crossbones&#10;&#10;AI-generated content may be incorrect.">
            <a:extLst>
              <a:ext uri="{FF2B5EF4-FFF2-40B4-BE49-F238E27FC236}">
                <a16:creationId xmlns:a16="http://schemas.microsoft.com/office/drawing/2014/main" id="{CFD0F136-8A31-29F5-D8AF-C3081B49FE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152255" y="2347932"/>
            <a:ext cx="1580399" cy="1340471"/>
          </a:xfrm>
          <a:prstGeom prst="rect">
            <a:avLst/>
          </a:prstGeom>
        </p:spPr>
      </p:pic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475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20000"/>
              </a:lnSpc>
            </a:pPr>
            <a:r>
              <a:rPr lang="en-US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cute kidney injury and early mortality in extremely preterm neonates born at 22-27 weeks gestation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22190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HYPOTHESIS:  </a:t>
            </a:r>
            <a:r>
              <a:rPr lang="en-US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Lower GA is linked to higher AKI, and AKI is linked to higher early mortality</a:t>
            </a:r>
            <a:endParaRPr lang="en-GB" dirty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Resnick et al. 2026</a:t>
            </a:r>
            <a:endParaRPr lang="en-GB" sz="1400" b="1" dirty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ONCLUSION: </a:t>
            </a:r>
            <a:r>
              <a:rPr lang="en-US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Lower GA predicts early AKI, and severe AKI shows the strongest association with early mortality.</a:t>
            </a:r>
            <a:endParaRPr lang="en-GB" dirty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2B6DA53-28F4-5E64-339A-A427E1AEA82A}"/>
              </a:ext>
            </a:extLst>
          </p:cNvPr>
          <p:cNvSpPr txBox="1"/>
          <p:nvPr/>
        </p:nvSpPr>
        <p:spPr>
          <a:xfrm>
            <a:off x="527212" y="1663177"/>
            <a:ext cx="5915818" cy="22467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i="0" dirty="0">
                <a:solidFill>
                  <a:srgbClr val="0065AA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Methods &amp; Outcom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b="1" i="0" dirty="0">
                <a:solidFill>
                  <a:srgbClr val="0065AA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Design:</a:t>
            </a:r>
            <a:r>
              <a:rPr lang="en-US" sz="2000" b="0" i="0" dirty="0">
                <a:solidFill>
                  <a:srgbClr val="0065AA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Retrospective cohort (UAB 2015-2021)</a:t>
            </a:r>
            <a:endParaRPr lang="en-US" sz="2000" dirty="0">
              <a:solidFill>
                <a:srgbClr val="0065AA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b="1" i="0" dirty="0">
                <a:solidFill>
                  <a:srgbClr val="0065AA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Population:</a:t>
            </a:r>
            <a:r>
              <a:rPr lang="en-US" sz="2000" b="0" i="0" dirty="0">
                <a:solidFill>
                  <a:srgbClr val="0065AA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487 neonates, GA 22+0 to 27+6 weeks, BW &gt;400g</a:t>
            </a:r>
            <a:endParaRPr lang="en-US" sz="2000" dirty="0">
              <a:solidFill>
                <a:srgbClr val="0065AA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b="1" i="0" dirty="0">
                <a:solidFill>
                  <a:srgbClr val="0065AA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Outcomes: </a:t>
            </a:r>
          </a:p>
          <a:p>
            <a:pPr marL="800100" lvl="1" indent="-342900">
              <a:buFont typeface="Wingdings" panose="05000000000000000000" pitchFamily="2" charset="2"/>
              <a:buChar char="Ø"/>
            </a:pPr>
            <a:r>
              <a:rPr lang="en-US" sz="2000" b="0" i="0" dirty="0">
                <a:solidFill>
                  <a:srgbClr val="0065AA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AKI (modified KDIGO), </a:t>
            </a:r>
          </a:p>
          <a:p>
            <a:pPr marL="800100" lvl="1" indent="-342900">
              <a:buFont typeface="Wingdings" panose="05000000000000000000" pitchFamily="2" charset="2"/>
              <a:buChar char="Ø"/>
            </a:pPr>
            <a:r>
              <a:rPr lang="en-US" sz="2000" b="0" i="0" dirty="0">
                <a:solidFill>
                  <a:srgbClr val="0065AA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Early </a:t>
            </a:r>
            <a:r>
              <a:rPr lang="en-US" sz="2000" dirty="0">
                <a:solidFill>
                  <a:srgbClr val="0065AA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ostnatal mortality (within 7 d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E1D58E2-8C50-836C-C336-870005C13066}"/>
              </a:ext>
            </a:extLst>
          </p:cNvPr>
          <p:cNvSpPr txBox="1"/>
          <p:nvPr/>
        </p:nvSpPr>
        <p:spPr>
          <a:xfrm>
            <a:off x="259080" y="4340733"/>
            <a:ext cx="622173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2000" b="1" i="0" dirty="0">
                <a:solidFill>
                  <a:srgbClr val="0065AA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Lower GA → Higher AKI incidence</a:t>
            </a:r>
            <a:endParaRPr lang="en-US" sz="2000" b="1" dirty="0">
              <a:solidFill>
                <a:srgbClr val="0065AA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000" i="0" dirty="0">
                <a:solidFill>
                  <a:srgbClr val="0065AA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22 weeks: 27%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000" dirty="0">
                <a:solidFill>
                  <a:srgbClr val="0065AA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7 weeks: 5%</a:t>
            </a:r>
            <a:endParaRPr lang="en-US" sz="2000" dirty="0">
              <a:solidFill>
                <a:srgbClr val="0065AA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" name="Rectangle 2">
            <a:extLst>
              <a:ext uri="{FF2B5EF4-FFF2-40B4-BE49-F238E27FC236}">
                <a16:creationId xmlns:a16="http://schemas.microsoft.com/office/drawing/2014/main" id="{551BA29B-0433-317E-FFC2-CA1A6EF2EE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dirty="0"/>
          </a:p>
        </p:txBody>
      </p:sp>
      <p:pic>
        <p:nvPicPr>
          <p:cNvPr id="22" name="Picture 21" descr="A baby in a box&#10;&#10;AI-generated content may be incorrect.">
            <a:extLst>
              <a:ext uri="{FF2B5EF4-FFF2-40B4-BE49-F238E27FC236}">
                <a16:creationId xmlns:a16="http://schemas.microsoft.com/office/drawing/2014/main" id="{272BBE3A-4915-B31A-945E-A4F0BE25122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42060" y="2437857"/>
            <a:ext cx="1445781" cy="1201274"/>
          </a:xfrm>
          <a:prstGeom prst="rect">
            <a:avLst/>
          </a:prstGeom>
        </p:spPr>
      </p:pic>
      <p:pic>
        <p:nvPicPr>
          <p:cNvPr id="31" name="Picture 30" descr="A cartoon of a kidney with lightning&#10;&#10;AI-generated content may be incorrect.">
            <a:extLst>
              <a:ext uri="{FF2B5EF4-FFF2-40B4-BE49-F238E27FC236}">
                <a16:creationId xmlns:a16="http://schemas.microsoft.com/office/drawing/2014/main" id="{E61DA286-B9A0-D2DC-23D0-F95464D3EA7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606740" y="2350113"/>
            <a:ext cx="1049453" cy="1336109"/>
          </a:xfrm>
          <a:prstGeom prst="rect">
            <a:avLst/>
          </a:prstGeom>
        </p:spPr>
      </p:pic>
      <p:pic>
        <p:nvPicPr>
          <p:cNvPr id="33" name="Picture 32" descr="A red arrow pointing to the right&#10;&#10;AI-generated content may be incorrect.">
            <a:extLst>
              <a:ext uri="{FF2B5EF4-FFF2-40B4-BE49-F238E27FC236}">
                <a16:creationId xmlns:a16="http://schemas.microsoft.com/office/drawing/2014/main" id="{859CD11F-A4FE-EACE-2542-D9D46392512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834496" y="2578756"/>
            <a:ext cx="1223676" cy="878822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6913961F-105E-A954-2597-1D79A8350FBC}"/>
              </a:ext>
            </a:extLst>
          </p:cNvPr>
          <p:cNvSpPr txBox="1"/>
          <p:nvPr/>
        </p:nvSpPr>
        <p:spPr>
          <a:xfrm>
            <a:off x="7606740" y="3792093"/>
            <a:ext cx="412166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2000" b="1" i="0" dirty="0">
                <a:solidFill>
                  <a:srgbClr val="0065AA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AKI → Higher Early Mortality</a:t>
            </a:r>
            <a:endParaRPr lang="en-US" sz="2000" dirty="0">
              <a:solidFill>
                <a:srgbClr val="0065AA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b="1" i="0" dirty="0">
                <a:solidFill>
                  <a:srgbClr val="0065AA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AKI: </a:t>
            </a:r>
            <a:r>
              <a:rPr lang="en-US" sz="2000" i="0" dirty="0">
                <a:solidFill>
                  <a:srgbClr val="0065AA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aOR</a:t>
            </a:r>
            <a:r>
              <a:rPr lang="en-US" sz="2000" b="1" i="0" dirty="0">
                <a:solidFill>
                  <a:srgbClr val="0065AA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2.48</a:t>
            </a:r>
            <a:r>
              <a:rPr lang="en-US" sz="2000" b="0" i="0" dirty="0">
                <a:solidFill>
                  <a:srgbClr val="0065AA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(0.88–7.02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b="1" dirty="0">
                <a:solidFill>
                  <a:srgbClr val="0065AA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</a:t>
            </a:r>
            <a:r>
              <a:rPr lang="en-US" sz="2000" b="1" i="0" dirty="0">
                <a:solidFill>
                  <a:srgbClr val="0065AA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evere AKI:</a:t>
            </a:r>
            <a:r>
              <a:rPr lang="en-US" sz="2000" b="0" i="0" dirty="0">
                <a:solidFill>
                  <a:srgbClr val="0065AA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2000" i="0" dirty="0">
                <a:solidFill>
                  <a:srgbClr val="0065AA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aOR</a:t>
            </a:r>
            <a:r>
              <a:rPr lang="en-US" sz="2000" b="1" i="0" dirty="0">
                <a:solidFill>
                  <a:srgbClr val="0065AA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3.99</a:t>
            </a:r>
            <a:r>
              <a:rPr lang="en-US" sz="2000" b="0" i="0" dirty="0">
                <a:solidFill>
                  <a:srgbClr val="0065AA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(0.94–16.9)</a:t>
            </a:r>
            <a:endParaRPr lang="en-US" sz="2000" dirty="0">
              <a:solidFill>
                <a:srgbClr val="0065AA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046da4d3-ba20-4986-879c-49e262eff745}" enabled="1" method="Standard" siteId="{9f693e63-5e9e-4ced-98a4-8ab28f9d0c2d}" removed="0"/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133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Wingding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esnick, Elad</dc:creator>
  <cp:lastModifiedBy>Joseph Laycock</cp:lastModifiedBy>
  <cp:revision>9</cp:revision>
  <dcterms:created xsi:type="dcterms:W3CDTF">2025-12-08T22:04:22Z</dcterms:created>
  <dcterms:modified xsi:type="dcterms:W3CDTF">2026-02-23T16:50:21Z</dcterms:modified>
</cp:coreProperties>
</file>